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240300-145A-B9CA-51D9-0812228865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D3A568-B1B6-BF8B-9C5B-F9516C68C0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967A27-4CA4-DDDA-0DAD-1C870C8626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7C8C1-9FA0-4D98-B6F7-15BCAEEE8C0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6E8D9C-CA3A-672B-EBEB-6ED490E1E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965352-D4B7-93DF-333C-5A39D53A5D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199A5-FD3C-40F6-A953-361A21CD36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62719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4E1D55-3C57-B26D-C6C8-D7BAA699B2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54E2FD-0AD7-5D08-E934-C870D1CC61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1DE952-9BD5-F3BC-E224-649BF58B1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7C8C1-9FA0-4D98-B6F7-15BCAEEE8C0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121E62-BE3C-1B41-C8B0-ACB40F7E1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55EDAA-712F-BAEA-32D8-A1FD04353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199A5-FD3C-40F6-A953-361A21CD36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56366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C91568D-ACF2-636D-EBF6-733619402A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758027-037A-85B2-465D-7D68E1F604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EB92A7-19AA-E260-FA49-E9ED7DCED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7C8C1-9FA0-4D98-B6F7-15BCAEEE8C0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CFA3D3-FE72-EDF7-19AA-AF29AAA85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270F5B-ED75-0F53-1735-483813818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199A5-FD3C-40F6-A953-361A21CD36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35687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D7962E-2D17-5432-18E1-FCA4E495BE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5B484C-02B4-9FF7-83EA-DCD73811C3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561226-577E-DD9A-A301-D450D27D2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7C8C1-9FA0-4D98-B6F7-15BCAEEE8C0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0C5A08-A3AB-2A98-B2C4-A3D66645BF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6EF08C-CBB4-91F9-791C-3E171ED96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199A5-FD3C-40F6-A953-361A21CD36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76734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1FB605-351B-F9A0-EB31-CAB4D23B3E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77B896-39EE-D115-ADD1-75CF66362D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63E4FE-5418-1492-ADDC-9F00EB410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7C8C1-9FA0-4D98-B6F7-15BCAEEE8C0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09D821-ADA3-2B72-E38C-52C53055F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6F6B10-6C14-4365-BE95-9A885D372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199A5-FD3C-40F6-A953-361A21CD36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14876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4DF936-7188-448A-FC69-D05186E4B0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279FB6-6ACF-87E8-C9F6-F185B8F449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B842AA-A260-59A9-27AD-82270A88F8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B02703-E52A-A3EE-B663-5D81BEB9B6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7C8C1-9FA0-4D98-B6F7-15BCAEEE8C0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A2E1B3-9A17-04AD-B76B-D85E5E90D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E397E5-CFE0-E72E-4DD7-D018A7F08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199A5-FD3C-40F6-A953-361A21CD36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73221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DD023B-A3D7-2F6C-4820-ABD65E8949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C915D8-A5EC-C0BF-0450-5A5592A55C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49FA26-E87E-3CDE-9621-0EE7DBA3E1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431F515-B8ED-5CDF-C686-AA6BCBBD85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B46A4A2-AA80-BB97-08AC-06BD3A5088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A4C0604-E974-3591-BF34-CF19C473DF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7C8C1-9FA0-4D98-B6F7-15BCAEEE8C0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FE9492C-7481-CD17-8BA5-A0DEB202B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C14AE59-3978-058C-30C3-8BA1C801A4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199A5-FD3C-40F6-A953-361A21CD36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36552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76A0C7-C4A8-3734-2C18-F0DD17B06D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8A3CEA-660A-A252-278F-E34CAC3BC2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7C8C1-9FA0-4D98-B6F7-15BCAEEE8C0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6655335-C103-FCCA-BC9B-8D345AA60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C3A1FE6-6469-5DC0-4CBD-E66C8017F1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199A5-FD3C-40F6-A953-361A21CD36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506835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872A4BE-7F7E-B611-99D1-4D65018D3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7C8C1-9FA0-4D98-B6F7-15BCAEEE8C0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1EE5870-9987-EC22-B52D-E74EA3073D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D5E0710-ED1E-25CC-D415-993320FF5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199A5-FD3C-40F6-A953-361A21CD36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537858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6C656D-93F3-17B2-C6EF-EEC97AD5A2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93DB30-8105-ECD3-4188-2557C30EBC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67F303-A479-D23C-8FC5-2AA1E0A8FB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97F345-95D0-37BE-ED1B-8DBB5A557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7C8C1-9FA0-4D98-B6F7-15BCAEEE8C0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D5328E-CDAA-37AC-1A3C-C99F4726C2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D43389-4A3A-C0DD-0B1E-F1FF33602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199A5-FD3C-40F6-A953-361A21CD36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884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E662D5-2407-4364-7173-19A342D35F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8AB0597-46A6-E0E0-9E34-D1BF5C4D23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4A7B5B-B141-202F-5141-1EF26C5A5D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453F47-9560-F0F1-23CD-E23854C16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7C8C1-9FA0-4D98-B6F7-15BCAEEE8C0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DBBCDB-7676-0076-04E4-945F81A2C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5FB021-2F5E-C80E-52BC-1CC084751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199A5-FD3C-40F6-A953-361A21CD36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36573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50EA6A9-173E-BF33-DE02-2C9B1B69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883098-83E8-5B89-65B5-BE5C3C3919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A479C7-78FD-3E94-4F26-D51293E8C8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7C8C1-9FA0-4D98-B6F7-15BCAEEE8C0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A641B0-A2FA-573E-530C-B85AC2F849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2F96E2-AFF7-94CE-7477-37FDD385B5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B199A5-FD3C-40F6-A953-361A21CD36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184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DAE98F6A-DAE0-3994-8ED2-04E8634D8BDC}"/>
              </a:ext>
            </a:extLst>
          </p:cNvPr>
          <p:cNvGrpSpPr/>
          <p:nvPr/>
        </p:nvGrpSpPr>
        <p:grpSpPr>
          <a:xfrm>
            <a:off x="1532853" y="591342"/>
            <a:ext cx="8802632" cy="4837703"/>
            <a:chOff x="8853" y="591341"/>
            <a:chExt cx="8802632" cy="483770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726FF8F-3B68-1ECF-97D0-F37F5B1A0C3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flipV="1">
              <a:off x="8854" y="1257299"/>
              <a:ext cx="2086517" cy="1602531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BE1EF36-20C1-8EED-C71B-4C8830100202}"/>
                </a:ext>
              </a:extLst>
            </p:cNvPr>
            <p:cNvSpPr txBox="1"/>
            <p:nvPr/>
          </p:nvSpPr>
          <p:spPr>
            <a:xfrm>
              <a:off x="537418" y="2850915"/>
              <a:ext cx="957512" cy="4154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50" dirty="0"/>
                <a:t>NCT </a:t>
              </a:r>
            </a:p>
            <a:p>
              <a:pPr algn="ctr"/>
              <a:r>
                <a:rPr lang="en-US" sz="1050" dirty="0"/>
                <a:t> ~110 </a:t>
              </a:r>
              <a:r>
                <a:rPr lang="en-US" sz="1050" dirty="0" err="1"/>
                <a:t>kDa</a:t>
              </a:r>
              <a:endParaRPr lang="en-US" sz="1050" dirty="0"/>
            </a:p>
          </p:txBody>
        </p:sp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B6F48F80-B184-FEC9-6296-524B16E61AA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95370" y="1531034"/>
              <a:ext cx="110096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18E78F88-EC49-A71F-DB14-5F9D478976A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51791" y="1199227"/>
              <a:ext cx="2184416" cy="1680856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48F0ECF-9476-AA40-7D87-2E1559420925}"/>
                </a:ext>
              </a:extLst>
            </p:cNvPr>
            <p:cNvSpPr txBox="1"/>
            <p:nvPr/>
          </p:nvSpPr>
          <p:spPr>
            <a:xfrm>
              <a:off x="2832649" y="2880082"/>
              <a:ext cx="957512" cy="4154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50" dirty="0"/>
                <a:t>PS-1</a:t>
              </a:r>
            </a:p>
            <a:p>
              <a:pPr algn="ctr"/>
              <a:r>
                <a:rPr lang="en-US" sz="1050" dirty="0"/>
                <a:t> ~48 </a:t>
              </a:r>
              <a:r>
                <a:rPr lang="en-US" sz="1050" dirty="0" err="1"/>
                <a:t>kDa</a:t>
              </a:r>
              <a:endParaRPr lang="en-US" sz="1050" dirty="0"/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0C79407-EFFE-8A29-2E2B-AD855D56020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467299" y="1241214"/>
              <a:ext cx="2010133" cy="1693754"/>
            </a:xfrm>
            <a:prstGeom prst="rect">
              <a:avLst/>
            </a:prstGeom>
          </p:spPr>
        </p:pic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5153F9DF-DFAC-1043-9365-87CE8945D21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38307" y="1966803"/>
              <a:ext cx="110096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3AA62814-02AF-98C1-094E-266D195C30C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514712" y="1966803"/>
              <a:ext cx="110096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61D83E6-E70E-D1E9-77A6-530DD34E63CE}"/>
                </a:ext>
              </a:extLst>
            </p:cNvPr>
            <p:cNvSpPr txBox="1"/>
            <p:nvPr/>
          </p:nvSpPr>
          <p:spPr>
            <a:xfrm>
              <a:off x="5030792" y="2934967"/>
              <a:ext cx="957512" cy="4154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50" dirty="0"/>
                <a:t>Tubulin</a:t>
              </a:r>
            </a:p>
            <a:p>
              <a:pPr algn="ctr"/>
              <a:r>
                <a:rPr lang="en-US" sz="1050" dirty="0"/>
                <a:t> ~48 </a:t>
              </a:r>
              <a:r>
                <a:rPr lang="en-US" sz="1050" dirty="0" err="1"/>
                <a:t>kDa</a:t>
              </a:r>
              <a:endParaRPr lang="en-US" sz="1050" dirty="0"/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F9951FB7-F986-585D-DC33-9A66B516A5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9594" t="-1" b="11297"/>
            <a:stretch/>
          </p:blipFill>
          <p:spPr>
            <a:xfrm rot="10800000" flipH="1">
              <a:off x="6667147" y="1367796"/>
              <a:ext cx="2110772" cy="1480483"/>
            </a:xfrm>
            <a:prstGeom prst="rect">
              <a:avLst/>
            </a:prstGeom>
          </p:spPr>
        </p:pic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4522301E-7FBB-C19C-BB25-BE29466C113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38351" y="3824119"/>
              <a:ext cx="110096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FF36C24-798E-735D-A8C7-8E1B0782ED4D}"/>
                </a:ext>
              </a:extLst>
            </p:cNvPr>
            <p:cNvSpPr txBox="1"/>
            <p:nvPr/>
          </p:nvSpPr>
          <p:spPr>
            <a:xfrm>
              <a:off x="7228935" y="2833201"/>
              <a:ext cx="957512" cy="4154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50" dirty="0"/>
                <a:t>APH</a:t>
              </a:r>
            </a:p>
            <a:p>
              <a:pPr algn="ctr"/>
              <a:r>
                <a:rPr lang="en-US" sz="1050" dirty="0"/>
                <a:t> ~29 </a:t>
              </a:r>
              <a:r>
                <a:rPr lang="en-US" sz="1050" dirty="0" err="1"/>
                <a:t>kDa</a:t>
              </a:r>
              <a:endParaRPr lang="en-US" sz="1050" dirty="0"/>
            </a:p>
          </p:txBody>
        </p: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D1D53D82-06FA-82A0-22B5-71C44726829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853" y="3371317"/>
              <a:ext cx="2629498" cy="1562078"/>
            </a:xfrm>
            <a:prstGeom prst="rect">
              <a:avLst/>
            </a:prstGeom>
          </p:spPr>
        </p:pic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5129F933-2E37-4D66-9F07-1751DFEA7E5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01389" y="2323931"/>
              <a:ext cx="110096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E5F4C57-96C9-152B-15C7-E0E983E7F9E6}"/>
                </a:ext>
              </a:extLst>
            </p:cNvPr>
            <p:cNvSpPr txBox="1"/>
            <p:nvPr/>
          </p:nvSpPr>
          <p:spPr>
            <a:xfrm>
              <a:off x="573355" y="5013546"/>
              <a:ext cx="957512" cy="4154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50" dirty="0"/>
                <a:t>Tubulin</a:t>
              </a:r>
            </a:p>
            <a:p>
              <a:pPr algn="ctr"/>
              <a:r>
                <a:rPr lang="en-US" sz="1050" dirty="0"/>
                <a:t> ~48 </a:t>
              </a:r>
              <a:r>
                <a:rPr lang="en-US" sz="1050" dirty="0" err="1"/>
                <a:t>kDa</a:t>
              </a:r>
              <a:endParaRPr lang="en-US" sz="1050" dirty="0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AD7E486A-A86A-E2F5-2812-10C94F57B9EF}"/>
                </a:ext>
              </a:extLst>
            </p:cNvPr>
            <p:cNvSpPr txBox="1"/>
            <p:nvPr/>
          </p:nvSpPr>
          <p:spPr>
            <a:xfrm>
              <a:off x="2011595" y="591341"/>
              <a:ext cx="47635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ull length blots for Supplementary figure 5P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19583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atakshi Shukla</dc:creator>
  <cp:lastModifiedBy>Shatakshi Shukla</cp:lastModifiedBy>
  <cp:revision>1</cp:revision>
  <dcterms:created xsi:type="dcterms:W3CDTF">2025-10-12T03:58:57Z</dcterms:created>
  <dcterms:modified xsi:type="dcterms:W3CDTF">2025-10-12T03:59:03Z</dcterms:modified>
</cp:coreProperties>
</file>